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41" autoAdjust="0"/>
    <p:restoredTop sz="94528" autoAdjust="0"/>
  </p:normalViewPr>
  <p:slideViewPr>
    <p:cSldViewPr>
      <p:cViewPr varScale="1">
        <p:scale>
          <a:sx n="79" d="100"/>
          <a:sy n="79" d="100"/>
        </p:scale>
        <p:origin x="2596" y="11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2C8DB5-CDA9-481E-B189-537F4C38F6D6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0AC790-2D1E-4412-9117-AAFFCA24BE22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F5CD-B8A8-45E1-9F8B-D070A762A445}" type="datetimeFigureOut">
              <a:rPr lang="zh-CN" altLang="en-US" smtClean="0"/>
              <a:pPr/>
              <a:t>2024/10/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C8459-5F45-4FAA-B89E-0CE5C31E6383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B004208C-2F79-2C2C-BE09-4B051ED4F8E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533" y="2116763"/>
            <a:ext cx="2340864" cy="15605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3EE39A6-0AF7-40BE-B4D7-4FC0741A508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0" y="498453"/>
            <a:ext cx="2341397" cy="1560932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104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2A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85530" y="211676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Rac1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B751630B-518F-0B9F-6F6D-5E945697D388}"/>
              </a:ext>
            </a:extLst>
          </p:cNvPr>
          <p:cNvSpPr/>
          <p:nvPr/>
        </p:nvSpPr>
        <p:spPr>
          <a:xfrm>
            <a:off x="764704" y="1287878"/>
            <a:ext cx="1080120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A60D1B7-126C-3FD7-FEDA-D014F5A2810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396554" y="498809"/>
            <a:ext cx="2340864" cy="1560576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B1402F4F-7D1E-00D8-41C8-4BB9EC77306E}"/>
              </a:ext>
            </a:extLst>
          </p:cNvPr>
          <p:cNvSpPr/>
          <p:nvPr/>
        </p:nvSpPr>
        <p:spPr>
          <a:xfrm>
            <a:off x="3130182" y="1287878"/>
            <a:ext cx="1080120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021A987-E052-9086-55C0-63A4820ED79F}"/>
              </a:ext>
            </a:extLst>
          </p:cNvPr>
          <p:cNvSpPr/>
          <p:nvPr/>
        </p:nvSpPr>
        <p:spPr>
          <a:xfrm>
            <a:off x="773352" y="2872054"/>
            <a:ext cx="1080120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>
            <a:extLst>
              <a:ext uri="{FF2B5EF4-FFF2-40B4-BE49-F238E27FC236}">
                <a16:creationId xmlns:a16="http://schemas.microsoft.com/office/drawing/2014/main" id="{FA50A8FA-3C8A-E8E2-3BAE-4F394DB3983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6284" y="448552"/>
            <a:ext cx="2340864" cy="156057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3D9784A-5907-412A-7456-BE8ECF8232B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48552"/>
            <a:ext cx="2340864" cy="1560576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31BED307-6897-0515-3B51-757AFBA14F2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-13862" y="2115440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02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2C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43972" y="211544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Rac1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B751630B-518F-0B9F-6F6D-5E945697D388}"/>
              </a:ext>
            </a:extLst>
          </p:cNvPr>
          <p:cNvSpPr/>
          <p:nvPr/>
        </p:nvSpPr>
        <p:spPr>
          <a:xfrm>
            <a:off x="668082" y="1336052"/>
            <a:ext cx="1080120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8" name="矩形 7">
            <a:extLst>
              <a:ext uri="{FF2B5EF4-FFF2-40B4-BE49-F238E27FC236}">
                <a16:creationId xmlns:a16="http://schemas.microsoft.com/office/drawing/2014/main" id="{B1402F4F-7D1E-00D8-41C8-4BB9EC77306E}"/>
              </a:ext>
            </a:extLst>
          </p:cNvPr>
          <p:cNvSpPr/>
          <p:nvPr/>
        </p:nvSpPr>
        <p:spPr>
          <a:xfrm>
            <a:off x="3046656" y="1280592"/>
            <a:ext cx="1080120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D021A987-E052-9086-55C0-63A4820ED79F}"/>
              </a:ext>
            </a:extLst>
          </p:cNvPr>
          <p:cNvSpPr/>
          <p:nvPr/>
        </p:nvSpPr>
        <p:spPr>
          <a:xfrm>
            <a:off x="759490" y="2872054"/>
            <a:ext cx="1080120" cy="136730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76456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309258A1-6C80-C9B1-14E9-E49FB2F2E2B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13904" y="459150"/>
            <a:ext cx="2340864" cy="156057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D0DF189D-8AEB-FCA4-690C-D5602D7F633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-49" y="462097"/>
            <a:ext cx="2340864" cy="156057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9592E05-A304-107F-FD88-9E3E6DE3374C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-49" y="2119597"/>
            <a:ext cx="2340864" cy="1560576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A931CE59-0C07-339A-7B75-9D415AD732F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396554" y="2119597"/>
            <a:ext cx="2340864" cy="1560576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18131561-E56C-186D-EB20-B0BB84D50ABD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9" y="3771730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216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2N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43972" y="2115440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P-AKT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Rac1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AKT</a:t>
            </a: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B751630B-518F-0B9F-6F6D-5E945697D388}"/>
              </a:ext>
            </a:extLst>
          </p:cNvPr>
          <p:cNvSpPr/>
          <p:nvPr/>
        </p:nvSpPr>
        <p:spPr>
          <a:xfrm>
            <a:off x="1193774" y="1178044"/>
            <a:ext cx="867074" cy="20509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81B07103-E21A-86E0-978B-6EAD0274DE68}"/>
              </a:ext>
            </a:extLst>
          </p:cNvPr>
          <p:cNvSpPr/>
          <p:nvPr/>
        </p:nvSpPr>
        <p:spPr>
          <a:xfrm>
            <a:off x="3249225" y="1280591"/>
            <a:ext cx="867074" cy="20509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AE7C58A4-2219-0414-802C-663EF0579496}"/>
              </a:ext>
            </a:extLst>
          </p:cNvPr>
          <p:cNvSpPr/>
          <p:nvPr/>
        </p:nvSpPr>
        <p:spPr>
          <a:xfrm>
            <a:off x="476615" y="4530119"/>
            <a:ext cx="867074" cy="20509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81644CC7-CF53-5701-74D9-95DBBCEE3942}"/>
              </a:ext>
            </a:extLst>
          </p:cNvPr>
          <p:cNvSpPr/>
          <p:nvPr/>
        </p:nvSpPr>
        <p:spPr>
          <a:xfrm>
            <a:off x="3595538" y="2895073"/>
            <a:ext cx="867074" cy="20509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A5578CFE-8DE7-EAC4-C292-07E29DFEFFAF}"/>
              </a:ext>
            </a:extLst>
          </p:cNvPr>
          <p:cNvSpPr/>
          <p:nvPr/>
        </p:nvSpPr>
        <p:spPr>
          <a:xfrm>
            <a:off x="725790" y="2969543"/>
            <a:ext cx="867074" cy="205095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TextBox 18">
            <a:extLst>
              <a:ext uri="{FF2B5EF4-FFF2-40B4-BE49-F238E27FC236}">
                <a16:creationId xmlns:a16="http://schemas.microsoft.com/office/drawing/2014/main" id="{A1AD3362-715F-9812-2990-384915DAECFF}"/>
              </a:ext>
            </a:extLst>
          </p:cNvPr>
          <p:cNvSpPr txBox="1"/>
          <p:nvPr/>
        </p:nvSpPr>
        <p:spPr>
          <a:xfrm>
            <a:off x="2403493" y="2125663"/>
            <a:ext cx="6174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</a:t>
            </a:r>
          </a:p>
        </p:txBody>
      </p:sp>
      <p:sp>
        <p:nvSpPr>
          <p:cNvPr id="23" name="TextBox 8">
            <a:extLst>
              <a:ext uri="{FF2B5EF4-FFF2-40B4-BE49-F238E27FC236}">
                <a16:creationId xmlns:a16="http://schemas.microsoft.com/office/drawing/2014/main" id="{B15C30F2-2CE5-D695-13D5-FF6D2C05D874}"/>
              </a:ext>
            </a:extLst>
          </p:cNvPr>
          <p:cNvSpPr txBox="1"/>
          <p:nvPr/>
        </p:nvSpPr>
        <p:spPr>
          <a:xfrm>
            <a:off x="-43972" y="377173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</p:spTree>
    <p:extLst>
      <p:ext uri="{BB962C8B-B14F-4D97-AF65-F5344CB8AC3E}">
        <p14:creationId xmlns:p14="http://schemas.microsoft.com/office/powerpoint/2010/main" val="3484116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>
            <a:extLst>
              <a:ext uri="{FF2B5EF4-FFF2-40B4-BE49-F238E27FC236}">
                <a16:creationId xmlns:a16="http://schemas.microsoft.com/office/drawing/2014/main" id="{C408CC1D-2028-CE6B-662A-3724C067FE0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3493" y="459150"/>
            <a:ext cx="2340864" cy="1560576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3F958FB8-C41B-8A57-9363-D52C383C017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-8265" y="448552"/>
            <a:ext cx="2340864" cy="156057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0EC8D16-FF8C-FF18-843D-EA5269BB7AE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-18747" y="2139055"/>
            <a:ext cx="2340864" cy="156057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3BED0AB-64BD-1CB2-BD31-614AFD9E7D5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/>
        </p:blipFill>
        <p:spPr>
          <a:xfrm>
            <a:off x="2468416" y="2139055"/>
            <a:ext cx="2340864" cy="1560576"/>
          </a:xfrm>
          <a:prstGeom prst="rect">
            <a:avLst/>
          </a:prstGeom>
        </p:spPr>
      </p:pic>
      <p:sp>
        <p:nvSpPr>
          <p:cNvPr id="30" name="TextBox 9">
            <a:extLst>
              <a:ext uri="{FF2B5EF4-FFF2-40B4-BE49-F238E27FC236}">
                <a16:creationId xmlns:a16="http://schemas.microsoft.com/office/drawing/2014/main" id="{6AA9658D-7E67-A202-5A44-6F4EE9EF5B74}"/>
              </a:ext>
            </a:extLst>
          </p:cNvPr>
          <p:cNvSpPr txBox="1"/>
          <p:nvPr/>
        </p:nvSpPr>
        <p:spPr>
          <a:xfrm>
            <a:off x="-34354" y="-25970"/>
            <a:ext cx="7248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Fig S2O</a:t>
            </a:r>
            <a:endParaRPr lang="zh-CN" altLang="en-US" sz="1400"/>
          </a:p>
        </p:txBody>
      </p:sp>
      <p:sp>
        <p:nvSpPr>
          <p:cNvPr id="34" name="TextBox 8">
            <a:extLst>
              <a:ext uri="{FF2B5EF4-FFF2-40B4-BE49-F238E27FC236}">
                <a16:creationId xmlns:a16="http://schemas.microsoft.com/office/drawing/2014/main" id="{AA944126-EE08-1B2E-AE03-A20F155D7D66}"/>
              </a:ext>
            </a:extLst>
          </p:cNvPr>
          <p:cNvSpPr txBox="1"/>
          <p:nvPr/>
        </p:nvSpPr>
        <p:spPr>
          <a:xfrm>
            <a:off x="-43972" y="2115440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-S</a:t>
            </a:r>
          </a:p>
        </p:txBody>
      </p:sp>
      <p:sp>
        <p:nvSpPr>
          <p:cNvPr id="35" name="TextBox 12">
            <a:extLst>
              <a:ext uri="{FF2B5EF4-FFF2-40B4-BE49-F238E27FC236}">
                <a16:creationId xmlns:a16="http://schemas.microsoft.com/office/drawing/2014/main" id="{06B5A100-F6F9-E274-B5C9-7A35F6390FF3}"/>
              </a:ext>
            </a:extLst>
          </p:cNvPr>
          <p:cNvSpPr txBox="1"/>
          <p:nvPr/>
        </p:nvSpPr>
        <p:spPr>
          <a:xfrm>
            <a:off x="-27384" y="459150"/>
            <a:ext cx="5357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Rac1</a:t>
            </a:r>
            <a:endParaRPr lang="zh-CN" altLang="en-US" sz="1400"/>
          </a:p>
        </p:txBody>
      </p:sp>
      <p:sp>
        <p:nvSpPr>
          <p:cNvPr id="41" name="TextBox 18">
            <a:extLst>
              <a:ext uri="{FF2B5EF4-FFF2-40B4-BE49-F238E27FC236}">
                <a16:creationId xmlns:a16="http://schemas.microsoft.com/office/drawing/2014/main" id="{CC72F15B-A8E7-4B1C-280A-5205D8F25970}"/>
              </a:ext>
            </a:extLst>
          </p:cNvPr>
          <p:cNvSpPr txBox="1"/>
          <p:nvPr/>
        </p:nvSpPr>
        <p:spPr>
          <a:xfrm>
            <a:off x="2396554" y="448552"/>
            <a:ext cx="7473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/>
              <a:t>HIF1α-L</a:t>
            </a:r>
          </a:p>
        </p:txBody>
      </p:sp>
      <p:sp>
        <p:nvSpPr>
          <p:cNvPr id="12" name="矩形 11">
            <a:extLst>
              <a:ext uri="{FF2B5EF4-FFF2-40B4-BE49-F238E27FC236}">
                <a16:creationId xmlns:a16="http://schemas.microsoft.com/office/drawing/2014/main" id="{81B07103-E21A-86E0-978B-6EAD0274DE68}"/>
              </a:ext>
            </a:extLst>
          </p:cNvPr>
          <p:cNvSpPr/>
          <p:nvPr/>
        </p:nvSpPr>
        <p:spPr>
          <a:xfrm>
            <a:off x="370079" y="1228840"/>
            <a:ext cx="1584176" cy="307777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TextBox 18">
            <a:extLst>
              <a:ext uri="{FF2B5EF4-FFF2-40B4-BE49-F238E27FC236}">
                <a16:creationId xmlns:a16="http://schemas.microsoft.com/office/drawing/2014/main" id="{A1AD3362-715F-9812-2990-384915DAECFF}"/>
              </a:ext>
            </a:extLst>
          </p:cNvPr>
          <p:cNvSpPr txBox="1"/>
          <p:nvPr/>
        </p:nvSpPr>
        <p:spPr>
          <a:xfrm>
            <a:off x="2403493" y="212566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sz="1400"/>
              <a:t>β-</a:t>
            </a:r>
            <a:r>
              <a:rPr lang="en-US" altLang="zh-CN" sz="1400"/>
              <a:t>Actin</a:t>
            </a:r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6CD1556F-31C1-8434-4E69-E32CFF347BC1}"/>
              </a:ext>
            </a:extLst>
          </p:cNvPr>
          <p:cNvSpPr/>
          <p:nvPr/>
        </p:nvSpPr>
        <p:spPr>
          <a:xfrm>
            <a:off x="326482" y="2928893"/>
            <a:ext cx="1584176" cy="24209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59716CCE-05D0-6DBB-E574-828C798AC3F7}"/>
              </a:ext>
            </a:extLst>
          </p:cNvPr>
          <p:cNvSpPr/>
          <p:nvPr/>
        </p:nvSpPr>
        <p:spPr>
          <a:xfrm>
            <a:off x="2846760" y="2945487"/>
            <a:ext cx="1584176" cy="24209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8EF78669-8FA8-6498-C058-1AD11F0F0FAB}"/>
              </a:ext>
            </a:extLst>
          </p:cNvPr>
          <p:cNvSpPr/>
          <p:nvPr/>
        </p:nvSpPr>
        <p:spPr>
          <a:xfrm>
            <a:off x="2854375" y="1266979"/>
            <a:ext cx="1584176" cy="242096"/>
          </a:xfrm>
          <a:prstGeom prst="rect">
            <a:avLst/>
          </a:prstGeom>
          <a:noFill/>
          <a:ln w="1905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17256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558</TotalTime>
  <Words>27</Words>
  <Application>Microsoft Office PowerPoint</Application>
  <PresentationFormat>A4 纸张(210x297 毫米)</PresentationFormat>
  <Paragraphs>19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微软中国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个人用户</dc:creator>
  <cp:lastModifiedBy>文龙 任</cp:lastModifiedBy>
  <cp:revision>248</cp:revision>
  <dcterms:created xsi:type="dcterms:W3CDTF">2023-02-16T12:33:32Z</dcterms:created>
  <dcterms:modified xsi:type="dcterms:W3CDTF">2024-10-07T17:37:35Z</dcterms:modified>
</cp:coreProperties>
</file>